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895C6FC-D80E-4B6E-94A6-C92922F4E14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15AFF1E-D275-47C3-BF02-3A51D8B25113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17D296-3789-444C-BA9D-85E0EE61FBB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B375C7-9DA7-401B-9CCF-2E872E2926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9A8D49-0CE8-4549-BBB2-267E34CF0A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F8345-B73A-451E-9899-12409C048E3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FA6F29-A2B7-42A2-A054-D6EBACCD33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9E3BF-CC87-4F8E-9775-817783EACF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F7E3B-C831-4C52-9089-7DEF2A0AA2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A858AA-9BCB-4C03-B854-5AC8CB0580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04FFCB-0B01-4ECC-94A0-B028BF7F80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258265-A265-45DD-996C-331269B617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FB2600-8C7E-4C11-B8B3-CED414A537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5E24A6-2277-453B-90A3-0635A94C38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39DAAA2-8BD8-469D-B817-796632537E4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1"/>
          <p:cNvGrpSpPr/>
          <p:nvPr/>
        </p:nvGrpSpPr>
        <p:grpSpPr>
          <a:xfrm>
            <a:off x="993600" y="0"/>
            <a:ext cx="8150400" cy="6858000"/>
            <a:chOff x="993600" y="0"/>
            <a:chExt cx="8150400" cy="6858000"/>
          </a:xfrm>
        </p:grpSpPr>
        <p:grpSp>
          <p:nvGrpSpPr>
            <p:cNvPr id="49" name="Group 1"/>
            <p:cNvGrpSpPr/>
            <p:nvPr/>
          </p:nvGrpSpPr>
          <p:grpSpPr>
            <a:xfrm>
              <a:off x="993600" y="0"/>
              <a:ext cx="6364800" cy="6858000"/>
              <a:chOff x="993600" y="0"/>
              <a:chExt cx="6364800" cy="6858000"/>
            </a:xfrm>
          </p:grpSpPr>
          <p:pic>
            <p:nvPicPr>
              <p:cNvPr id="50" name="Picture 5" descr=""/>
              <p:cNvPicPr/>
              <p:nvPr/>
            </p:nvPicPr>
            <p:blipFill>
              <a:blip r:embed="rId1"/>
              <a:stretch/>
            </p:blipFill>
            <p:spPr>
              <a:xfrm>
                <a:off x="993600" y="0"/>
                <a:ext cx="6364800" cy="6858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1" name="TextBox 12"/>
              <p:cNvSpPr/>
              <p:nvPr/>
            </p:nvSpPr>
            <p:spPr>
              <a:xfrm>
                <a:off x="1438200" y="1823040"/>
                <a:ext cx="3860640" cy="307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GB" sz="14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rude P603 - LLSYFGTPT (r.t 7.1 min) 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TextBox 12"/>
              <p:cNvSpPr/>
              <p:nvPr/>
            </p:nvSpPr>
            <p:spPr>
              <a:xfrm>
                <a:off x="1438200" y="5292000"/>
                <a:ext cx="4157640" cy="307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GB" sz="14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rude P603 - LLSY(3-</a:t>
                </a:r>
                <a:r>
                  <a:rPr b="1" i="1" lang="en-GB" sz="14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t</a:t>
                </a:r>
                <a:r>
                  <a:rPr b="1" lang="en-GB" sz="14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Bu)FGTPT (r.t 9.5 min)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TextBox 12"/>
              <p:cNvSpPr/>
              <p:nvPr/>
            </p:nvSpPr>
            <p:spPr>
              <a:xfrm>
                <a:off x="1438200" y="3550320"/>
                <a:ext cx="3816000" cy="307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GB" sz="14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rude P603 - LLLSYFGTPT (r.t 8.0 min) 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TextBox 12"/>
              <p:cNvSpPr/>
              <p:nvPr/>
            </p:nvSpPr>
            <p:spPr>
              <a:xfrm>
                <a:off x="1438200" y="149400"/>
                <a:ext cx="3843000" cy="307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GB" sz="14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Purified P603 - LLSYFGTPT (r.t 7.1 min) 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5" name="TextBox 10"/>
            <p:cNvSpPr/>
            <p:nvPr/>
          </p:nvSpPr>
          <p:spPr>
            <a:xfrm>
              <a:off x="7431480" y="6140880"/>
              <a:ext cx="1712520" cy="54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Supplementary Figure 1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13T11:44:58Z</dcterms:created>
  <dc:creator>Information Services</dc:creator>
  <dc:description/>
  <dc:language>en-US</dc:language>
  <cp:lastModifiedBy>Information Services</cp:lastModifiedBy>
  <dcterms:modified xsi:type="dcterms:W3CDTF">2014-09-30T15:13:25Z</dcterms:modified>
  <cp:revision>169</cp:revision>
  <dc:subject/>
  <dc:title>PowerPoint Presentation</dc:title>
</cp:coreProperties>
</file>